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9144000" cy="6858000" type="screen4x3"/>
  <p:notesSz cx="7010400" cy="92233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zan, Heba Fathy" initials="AHF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45" autoAdjust="0"/>
    <p:restoredTop sz="94512" autoAdjust="0"/>
  </p:normalViewPr>
  <p:slideViewPr>
    <p:cSldViewPr>
      <p:cViewPr varScale="1">
        <p:scale>
          <a:sx n="74" d="100"/>
          <a:sy n="74" d="100"/>
        </p:scale>
        <p:origin x="113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2FA3D-2F7A-4AA2-95AC-80D01F2A9AF3}" type="datetimeFigureOut">
              <a:rPr lang="en-US" smtClean="0"/>
              <a:t>4/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1103"/>
            <a:ext cx="5608320" cy="415051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734BAE-C534-479E-A9FC-EAFBA29B5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936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Figure 1:Schematic description of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in vivo</a:t>
            </a:r>
            <a:r>
              <a:rPr lang="en-US" sz="12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 experiments sample collection and analysis from vaccination using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B. </a:t>
            </a:r>
            <a:r>
              <a:rPr lang="en-US" sz="1200" i="1" dirty="0" err="1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bovis</a:t>
            </a:r>
            <a:r>
              <a:rPr lang="en-US" sz="1200" i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6-Cys A and B proteins</a:t>
            </a:r>
            <a:r>
              <a:rPr lang="en-US" sz="1200" i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734BAE-C534-479E-A9FC-EAFBA29B50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1726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riangle 8">
            <a:extLst>
              <a:ext uri="{FF2B5EF4-FFF2-40B4-BE49-F238E27FC236}">
                <a16:creationId xmlns:a16="http://schemas.microsoft.com/office/drawing/2014/main" xmlns="" id="{EB26AD8F-8DA2-924E-8699-CA65EEC26DA2}"/>
              </a:ext>
            </a:extLst>
          </p:cNvPr>
          <p:cNvSpPr/>
          <p:nvPr/>
        </p:nvSpPr>
        <p:spPr>
          <a:xfrm>
            <a:off x="5155701" y="3771849"/>
            <a:ext cx="3150067" cy="2019351"/>
          </a:xfrm>
          <a:prstGeom prst="triangle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ck weight</a:t>
            </a:r>
          </a:p>
          <a:p>
            <a:pPr algn="ctr"/>
            <a:r>
              <a:rPr lang="en-US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lymph</a:t>
            </a:r>
          </a:p>
          <a:p>
            <a:pPr algn="ctr"/>
            <a:r>
              <a:rPr lang="en-US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gs</a:t>
            </a:r>
          </a:p>
          <a:p>
            <a:pPr algn="ctr"/>
            <a:r>
              <a:rPr lang="en-US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rvae</a:t>
            </a:r>
          </a:p>
          <a:p>
            <a:pPr algn="ctr"/>
            <a:endParaRPr lang="en-US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4D8221BE-4708-734F-98BD-1411632246FA}"/>
              </a:ext>
            </a:extLst>
          </p:cNvPr>
          <p:cNvGrpSpPr/>
          <p:nvPr/>
        </p:nvGrpSpPr>
        <p:grpSpPr>
          <a:xfrm>
            <a:off x="457200" y="304800"/>
            <a:ext cx="8305800" cy="5705027"/>
            <a:chOff x="457200" y="304800"/>
            <a:chExt cx="8305800" cy="5705027"/>
          </a:xfrm>
        </p:grpSpPr>
        <p:sp>
          <p:nvSpPr>
            <p:cNvPr id="4" name="Rounded Rectangle 3">
              <a:extLst>
                <a:ext uri="{FF2B5EF4-FFF2-40B4-BE49-F238E27FC236}">
                  <a16:creationId xmlns:a16="http://schemas.microsoft.com/office/drawing/2014/main" xmlns="" id="{0C68CFD0-B16A-0D48-8EBD-1EA9445C719A}"/>
                </a:ext>
              </a:extLst>
            </p:cNvPr>
            <p:cNvSpPr/>
            <p:nvPr/>
          </p:nvSpPr>
          <p:spPr>
            <a:xfrm>
              <a:off x="457200" y="304800"/>
              <a:ext cx="865128" cy="1219200"/>
            </a:xfrm>
            <a:prstGeom prst="roundRect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t"/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mmunized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cys A &amp; B proteins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/>
                <a:t> </a:t>
              </a:r>
            </a:p>
          </p:txBody>
        </p:sp>
        <p:sp>
          <p:nvSpPr>
            <p:cNvPr id="2" name="Rounded Rectangle 1">
              <a:extLst>
                <a:ext uri="{FF2B5EF4-FFF2-40B4-BE49-F238E27FC236}">
                  <a16:creationId xmlns:a16="http://schemas.microsoft.com/office/drawing/2014/main" xmlns="" id="{5C7051D6-E649-2146-8A15-691F0EB84ADE}"/>
                </a:ext>
              </a:extLst>
            </p:cNvPr>
            <p:cNvSpPr/>
            <p:nvPr/>
          </p:nvSpPr>
          <p:spPr>
            <a:xfrm>
              <a:off x="1296635" y="304801"/>
              <a:ext cx="2971566" cy="1242951"/>
            </a:xfrm>
            <a:prstGeom prst="round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" name="Rounded Rectangle 4">
              <a:extLst>
                <a:ext uri="{FF2B5EF4-FFF2-40B4-BE49-F238E27FC236}">
                  <a16:creationId xmlns:a16="http://schemas.microsoft.com/office/drawing/2014/main" xmlns="" id="{D73FC864-8530-4742-B8A5-6CA538C7CCD2}"/>
                </a:ext>
              </a:extLst>
            </p:cNvPr>
            <p:cNvSpPr/>
            <p:nvPr/>
          </p:nvSpPr>
          <p:spPr>
            <a:xfrm>
              <a:off x="8000727" y="304800"/>
              <a:ext cx="762273" cy="1219199"/>
            </a:xfrm>
            <a:prstGeom prst="roundRect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t"/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djuvant</a:t>
              </a:r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</a:p>
          </p:txBody>
        </p:sp>
        <p:sp>
          <p:nvSpPr>
            <p:cNvPr id="3" name="Rounded Rectangle 2">
              <a:extLst>
                <a:ext uri="{FF2B5EF4-FFF2-40B4-BE49-F238E27FC236}">
                  <a16:creationId xmlns:a16="http://schemas.microsoft.com/office/drawing/2014/main" xmlns="" id="{4421D35C-62F2-C04E-A8A9-7139E7CF8ABB}"/>
                </a:ext>
              </a:extLst>
            </p:cNvPr>
            <p:cNvSpPr/>
            <p:nvPr/>
          </p:nvSpPr>
          <p:spPr>
            <a:xfrm>
              <a:off x="5054854" y="304800"/>
              <a:ext cx="3037062" cy="1219199"/>
            </a:xfrm>
            <a:prstGeom prst="round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53F7737B-2DB9-C946-9EE6-2E3167B751B0}"/>
                </a:ext>
              </a:extLst>
            </p:cNvPr>
            <p:cNvSpPr/>
            <p:nvPr/>
          </p:nvSpPr>
          <p:spPr>
            <a:xfrm>
              <a:off x="1792268" y="1143000"/>
              <a:ext cx="18277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pleen intact calves 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F362ED80-931F-844A-A77A-EF3312F104CB}"/>
                </a:ext>
              </a:extLst>
            </p:cNvPr>
            <p:cNvSpPr/>
            <p:nvPr/>
          </p:nvSpPr>
          <p:spPr>
            <a:xfrm>
              <a:off x="5562600" y="1143000"/>
              <a:ext cx="18277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pleen intact calves </a:t>
              </a:r>
            </a:p>
          </p:txBody>
        </p:sp>
        <p:sp>
          <p:nvSpPr>
            <p:cNvPr id="8" name="Triangle 7">
              <a:extLst>
                <a:ext uri="{FF2B5EF4-FFF2-40B4-BE49-F238E27FC236}">
                  <a16:creationId xmlns:a16="http://schemas.microsoft.com/office/drawing/2014/main" xmlns="" id="{9B2436C3-3794-9A4C-910A-F659A4796AF2}"/>
                </a:ext>
              </a:extLst>
            </p:cNvPr>
            <p:cNvSpPr/>
            <p:nvPr/>
          </p:nvSpPr>
          <p:spPr>
            <a:xfrm>
              <a:off x="914400" y="3774390"/>
              <a:ext cx="3202926" cy="2016809"/>
            </a:xfrm>
            <a:prstGeom prst="triangl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ck weight</a:t>
              </a:r>
            </a:p>
            <a:p>
              <a:pPr algn="ctr"/>
              <a:r>
                <a:rPr lang="en-US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molymph</a:t>
              </a:r>
            </a:p>
            <a:p>
              <a:pPr algn="ctr"/>
              <a:r>
                <a:rPr lang="en-US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gs</a:t>
              </a:r>
            </a:p>
            <a:p>
              <a:pPr algn="ctr"/>
              <a:r>
                <a:rPr lang="en-US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rvae</a:t>
              </a:r>
            </a:p>
            <a:p>
              <a:pPr algn="ctr"/>
              <a:r>
                <a:rPr lang="en-US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xmlns="" id="{53FA108B-BE77-1E40-A69B-5D5506458741}"/>
                </a:ext>
              </a:extLst>
            </p:cNvPr>
            <p:cNvSpPr/>
            <p:nvPr/>
          </p:nvSpPr>
          <p:spPr>
            <a:xfrm>
              <a:off x="2057400" y="2133600"/>
              <a:ext cx="914400" cy="914400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xmlns="" id="{A39FA228-0D42-9A49-A526-41DDDD88051A}"/>
                </a:ext>
              </a:extLst>
            </p:cNvPr>
            <p:cNvSpPr/>
            <p:nvPr/>
          </p:nvSpPr>
          <p:spPr>
            <a:xfrm>
              <a:off x="6248400" y="2133600"/>
              <a:ext cx="914400" cy="914400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xmlns="" id="{1BF6F0C5-979F-B14E-A65E-B5F43479E0E9}"/>
                </a:ext>
              </a:extLst>
            </p:cNvPr>
            <p:cNvCxnSpPr/>
            <p:nvPr/>
          </p:nvCxnSpPr>
          <p:spPr>
            <a:xfrm>
              <a:off x="2514600" y="1676400"/>
              <a:ext cx="0" cy="378514"/>
            </a:xfrm>
            <a:prstGeom prst="straightConnector1">
              <a:avLst/>
            </a:prstGeom>
            <a:ln w="101600"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xmlns="" id="{4BCC0AF0-9DCD-2344-9BF8-6ABD257ECD0E}"/>
                </a:ext>
              </a:extLst>
            </p:cNvPr>
            <p:cNvCxnSpPr/>
            <p:nvPr/>
          </p:nvCxnSpPr>
          <p:spPr>
            <a:xfrm>
              <a:off x="6705600" y="1676400"/>
              <a:ext cx="0" cy="378514"/>
            </a:xfrm>
            <a:prstGeom prst="straightConnector1">
              <a:avLst/>
            </a:prstGeom>
            <a:ln w="101600"/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</p:cxn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08A4A74D-373F-754C-99AC-BF6C1B55CC30}"/>
                </a:ext>
              </a:extLst>
            </p:cNvPr>
            <p:cNvSpPr/>
            <p:nvPr/>
          </p:nvSpPr>
          <p:spPr>
            <a:xfrm>
              <a:off x="3300672" y="1600200"/>
              <a:ext cx="256672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nfection by 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Babesia </a:t>
              </a:r>
              <a:r>
                <a:rPr lang="en-US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vis</a:t>
              </a:r>
              <a:endParaRPr lang="en-US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977767D5-965A-1D45-A42C-7B148D0D7516}"/>
                </a:ext>
              </a:extLst>
            </p:cNvPr>
            <p:cNvSpPr/>
            <p:nvPr/>
          </p:nvSpPr>
          <p:spPr>
            <a:xfrm>
              <a:off x="3657600" y="2209800"/>
              <a:ext cx="160210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Tick infestation 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7357D162-DE9F-9245-81F2-55C85D5DAD5A}"/>
                </a:ext>
              </a:extLst>
            </p:cNvPr>
            <p:cNvSpPr/>
            <p:nvPr/>
          </p:nvSpPr>
          <p:spPr>
            <a:xfrm>
              <a:off x="3969294" y="2819400"/>
              <a:ext cx="118013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ncubation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xmlns="" id="{1D403BEF-BAED-1D4F-A18A-0155BA376B10}"/>
                </a:ext>
              </a:extLst>
            </p:cNvPr>
            <p:cNvCxnSpPr/>
            <p:nvPr/>
          </p:nvCxnSpPr>
          <p:spPr>
            <a:xfrm>
              <a:off x="2514600" y="3124200"/>
              <a:ext cx="0" cy="378514"/>
            </a:xfrm>
            <a:prstGeom prst="straightConnector1">
              <a:avLst/>
            </a:prstGeom>
            <a:ln w="101600"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xmlns="" id="{42AFBCC4-CDF7-D543-A7F1-6F4B27F06CB8}"/>
                </a:ext>
              </a:extLst>
            </p:cNvPr>
            <p:cNvCxnSpPr/>
            <p:nvPr/>
          </p:nvCxnSpPr>
          <p:spPr>
            <a:xfrm>
              <a:off x="6705600" y="3124200"/>
              <a:ext cx="0" cy="378514"/>
            </a:xfrm>
            <a:prstGeom prst="straightConnector1">
              <a:avLst/>
            </a:prstGeom>
            <a:ln w="101600"/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</p:cxnSp>
        <p:sp>
          <p:nvSpPr>
            <p:cNvPr id="21" name="Notched Right Arrow 20">
              <a:extLst>
                <a:ext uri="{FF2B5EF4-FFF2-40B4-BE49-F238E27FC236}">
                  <a16:creationId xmlns:a16="http://schemas.microsoft.com/office/drawing/2014/main" xmlns="" id="{64B36511-3CEB-B543-B029-E853C5A8762C}"/>
                </a:ext>
              </a:extLst>
            </p:cNvPr>
            <p:cNvSpPr/>
            <p:nvPr/>
          </p:nvSpPr>
          <p:spPr>
            <a:xfrm>
              <a:off x="533407" y="1627941"/>
              <a:ext cx="1142993" cy="445532"/>
            </a:xfrm>
            <a:prstGeom prst="notchedRightArrow">
              <a:avLst/>
            </a:prstGeom>
            <a:solidFill>
              <a:srgbClr val="FFFF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22" name="Notched Right Arrow 21">
              <a:extLst>
                <a:ext uri="{FF2B5EF4-FFF2-40B4-BE49-F238E27FC236}">
                  <a16:creationId xmlns:a16="http://schemas.microsoft.com/office/drawing/2014/main" xmlns="" id="{40D45BEB-26C8-BD43-ACBA-A91DCC68E97D}"/>
                </a:ext>
              </a:extLst>
            </p:cNvPr>
            <p:cNvSpPr/>
            <p:nvPr/>
          </p:nvSpPr>
          <p:spPr>
            <a:xfrm>
              <a:off x="533407" y="2297668"/>
              <a:ext cx="1142993" cy="445532"/>
            </a:xfrm>
            <a:prstGeom prst="notchedRightArrow">
              <a:avLst/>
            </a:prstGeom>
            <a:solidFill>
              <a:srgbClr val="FFFF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23" name="Notched Right Arrow 22">
              <a:extLst>
                <a:ext uri="{FF2B5EF4-FFF2-40B4-BE49-F238E27FC236}">
                  <a16:creationId xmlns:a16="http://schemas.microsoft.com/office/drawing/2014/main" xmlns="" id="{F886C5A3-C1D6-5747-8CF0-DE688205727F}"/>
                </a:ext>
              </a:extLst>
            </p:cNvPr>
            <p:cNvSpPr/>
            <p:nvPr/>
          </p:nvSpPr>
          <p:spPr>
            <a:xfrm>
              <a:off x="533407" y="3124200"/>
              <a:ext cx="1142993" cy="445532"/>
            </a:xfrm>
            <a:prstGeom prst="notchedRightArrow">
              <a:avLst/>
            </a:prstGeom>
            <a:solidFill>
              <a:srgbClr val="FFFF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24" name="Left-Right Arrow 23">
              <a:extLst>
                <a:ext uri="{FF2B5EF4-FFF2-40B4-BE49-F238E27FC236}">
                  <a16:creationId xmlns:a16="http://schemas.microsoft.com/office/drawing/2014/main" xmlns="" id="{F06D91C6-4C88-E246-B21B-A89A218D57F9}"/>
                </a:ext>
              </a:extLst>
            </p:cNvPr>
            <p:cNvSpPr/>
            <p:nvPr/>
          </p:nvSpPr>
          <p:spPr>
            <a:xfrm>
              <a:off x="3420989" y="3200400"/>
              <a:ext cx="2217811" cy="933093"/>
            </a:xfrm>
            <a:prstGeom prst="leftRightArrow">
              <a:avLst/>
            </a:prstGeom>
            <a:solidFill>
              <a:srgbClr val="FFFF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ected Tick Analysis 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xmlns="" id="{E12A7505-7601-6F49-AA0E-8A319870E0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2" t="40186" r="48374" b="10182"/>
            <a:stretch/>
          </p:blipFill>
          <p:spPr>
            <a:xfrm>
              <a:off x="4114800" y="4488751"/>
              <a:ext cx="831584" cy="537817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xmlns="" id="{A5B1BBB1-9283-9645-B63D-78BBACBD78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29" t="6493" r="1980" b="3146"/>
            <a:stretch/>
          </p:blipFill>
          <p:spPr>
            <a:xfrm>
              <a:off x="1371655" y="381000"/>
              <a:ext cx="837875" cy="706963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xmlns="" id="{F39377A2-641C-1B44-BCD1-39FF89DD35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29" t="6493" r="1980" b="3146"/>
            <a:stretch/>
          </p:blipFill>
          <p:spPr>
            <a:xfrm>
              <a:off x="2362368" y="381000"/>
              <a:ext cx="838247" cy="707277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xmlns="" id="{EF94234E-FFD8-0044-ACDF-AC7B564C94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29" t="6493" r="1980" b="3146"/>
            <a:stretch/>
          </p:blipFill>
          <p:spPr>
            <a:xfrm>
              <a:off x="3378445" y="426401"/>
              <a:ext cx="838247" cy="707277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xmlns="" id="{5A66F115-B570-1645-B163-451A626977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29" t="6493" r="1980" b="3146"/>
            <a:stretch/>
          </p:blipFill>
          <p:spPr>
            <a:xfrm>
              <a:off x="5181983" y="426715"/>
              <a:ext cx="837875" cy="706963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xmlns="" id="{BB2FFD8F-E52C-BD47-BDAF-98ED19D88A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29" t="6493" r="1980" b="3146"/>
            <a:stretch/>
          </p:blipFill>
          <p:spPr>
            <a:xfrm>
              <a:off x="6172368" y="427768"/>
              <a:ext cx="838247" cy="707277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xmlns="" id="{177B2608-83B7-2C4B-A3EF-9B3350A2A8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29" t="6493" r="1980" b="3146"/>
            <a:stretch/>
          </p:blipFill>
          <p:spPr>
            <a:xfrm>
              <a:off x="7162480" y="431994"/>
              <a:ext cx="838247" cy="707277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xmlns="" id="{DA3151D8-EFD9-854F-9819-BAD306A0E4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2101"/>
            <a:stretch/>
          </p:blipFill>
          <p:spPr>
            <a:xfrm>
              <a:off x="4224177" y="3886200"/>
              <a:ext cx="625015" cy="664971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xmlns="" id="{6FC7A887-A19B-BC44-82F7-40AA0E124C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584" t="14365"/>
            <a:stretch/>
          </p:blipFill>
          <p:spPr>
            <a:xfrm>
              <a:off x="2124091" y="2284983"/>
              <a:ext cx="689296" cy="621003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xmlns="" id="{54AFA594-1184-1246-A185-F48046A11C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584" t="14365"/>
            <a:stretch/>
          </p:blipFill>
          <p:spPr>
            <a:xfrm>
              <a:off x="6330613" y="2284983"/>
              <a:ext cx="689296" cy="621003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xmlns="" id="{EBF7A11B-89F2-AB4F-8F43-95DDAE3986D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191000" y="5483768"/>
              <a:ext cx="783572" cy="526059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xmlns="" id="{F9FA281F-09CD-5E48-A894-3CDBB8F1C8D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156208" y="4874168"/>
              <a:ext cx="831584" cy="738388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</p:spPr>
        </p:pic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ECDCA442-4AA0-024B-BC8F-C221F45B1CE0}"/>
                </a:ext>
              </a:extLst>
            </p:cNvPr>
            <p:cNvCxnSpPr>
              <a:cxnSpLocks/>
            </p:cNvCxnSpPr>
            <p:nvPr/>
          </p:nvCxnSpPr>
          <p:spPr>
            <a:xfrm>
              <a:off x="4419600" y="1958385"/>
              <a:ext cx="0" cy="2955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xmlns="" id="{7749C014-1EE5-E247-A348-CFE35AB6962F}"/>
                </a:ext>
              </a:extLst>
            </p:cNvPr>
            <p:cNvCxnSpPr>
              <a:cxnSpLocks/>
            </p:cNvCxnSpPr>
            <p:nvPr/>
          </p:nvCxnSpPr>
          <p:spPr>
            <a:xfrm>
              <a:off x="4419600" y="2600036"/>
              <a:ext cx="0" cy="2955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xmlns="" id="{95C23B00-249D-0E42-83E7-D4FE42E1BD4A}"/>
                </a:ext>
              </a:extLst>
            </p:cNvPr>
            <p:cNvCxnSpPr/>
            <p:nvPr/>
          </p:nvCxnSpPr>
          <p:spPr>
            <a:xfrm>
              <a:off x="4191000" y="533400"/>
              <a:ext cx="0" cy="554182"/>
            </a:xfrm>
            <a:prstGeom prst="straightConnector1">
              <a:avLst/>
            </a:prstGeom>
            <a:ln w="101600">
              <a:solidFill>
                <a:schemeClr val="bg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xmlns="" id="{387183A4-AA54-F14B-B116-CF022B86EB44}"/>
                </a:ext>
              </a:extLst>
            </p:cNvPr>
            <p:cNvCxnSpPr/>
            <p:nvPr/>
          </p:nvCxnSpPr>
          <p:spPr>
            <a:xfrm>
              <a:off x="3200400" y="457200"/>
              <a:ext cx="0" cy="554182"/>
            </a:xfrm>
            <a:prstGeom prst="straightConnector1">
              <a:avLst/>
            </a:prstGeom>
            <a:ln w="101600">
              <a:solidFill>
                <a:schemeClr val="bg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xmlns="" id="{50273EA7-2F96-1F42-BFD0-A042999769CE}"/>
                </a:ext>
              </a:extLst>
            </p:cNvPr>
            <p:cNvCxnSpPr/>
            <p:nvPr/>
          </p:nvCxnSpPr>
          <p:spPr>
            <a:xfrm>
              <a:off x="2209530" y="533400"/>
              <a:ext cx="0" cy="554182"/>
            </a:xfrm>
            <a:prstGeom prst="straightConnector1">
              <a:avLst/>
            </a:prstGeom>
            <a:ln w="101600">
              <a:solidFill>
                <a:schemeClr val="bg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xmlns="" id="{98B3FC4E-5E61-EF42-89E9-0B346505E0B0}"/>
                </a:ext>
              </a:extLst>
            </p:cNvPr>
            <p:cNvCxnSpPr/>
            <p:nvPr/>
          </p:nvCxnSpPr>
          <p:spPr>
            <a:xfrm>
              <a:off x="6019588" y="588818"/>
              <a:ext cx="0" cy="554182"/>
            </a:xfrm>
            <a:prstGeom prst="straightConnector1">
              <a:avLst/>
            </a:prstGeom>
            <a:ln w="101600">
              <a:solidFill>
                <a:schemeClr val="bg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xmlns="" id="{0B0D096C-B33D-F24F-92C1-452D3BF4416B}"/>
                </a:ext>
              </a:extLst>
            </p:cNvPr>
            <p:cNvCxnSpPr/>
            <p:nvPr/>
          </p:nvCxnSpPr>
          <p:spPr>
            <a:xfrm>
              <a:off x="7010615" y="533400"/>
              <a:ext cx="0" cy="554182"/>
            </a:xfrm>
            <a:prstGeom prst="straightConnector1">
              <a:avLst/>
            </a:prstGeom>
            <a:ln w="101600">
              <a:solidFill>
                <a:schemeClr val="bg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xmlns="" id="{465B4DFF-C868-F644-A0E7-1C87C3528554}"/>
                </a:ext>
              </a:extLst>
            </p:cNvPr>
            <p:cNvCxnSpPr/>
            <p:nvPr/>
          </p:nvCxnSpPr>
          <p:spPr>
            <a:xfrm>
              <a:off x="8000727" y="533400"/>
              <a:ext cx="0" cy="554182"/>
            </a:xfrm>
            <a:prstGeom prst="straightConnector1">
              <a:avLst/>
            </a:prstGeom>
            <a:ln w="101600">
              <a:solidFill>
                <a:schemeClr val="bg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</p:cxn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0628EF1F-26C5-A042-975B-5BB9A72E5609}"/>
              </a:ext>
            </a:extLst>
          </p:cNvPr>
          <p:cNvSpPr txBox="1"/>
          <p:nvPr/>
        </p:nvSpPr>
        <p:spPr>
          <a:xfrm>
            <a:off x="8182507" y="6336268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2</a:t>
            </a:r>
          </a:p>
        </p:txBody>
      </p:sp>
    </p:spTree>
    <p:extLst>
      <p:ext uri="{BB962C8B-B14F-4D97-AF65-F5344CB8AC3E}">
        <p14:creationId xmlns:p14="http://schemas.microsoft.com/office/powerpoint/2010/main" val="3975458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42</TotalTime>
  <Words>64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Pon Abirami A.</cp:lastModifiedBy>
  <cp:revision>178</cp:revision>
  <dcterms:created xsi:type="dcterms:W3CDTF">2020-04-03T19:59:23Z</dcterms:created>
  <dcterms:modified xsi:type="dcterms:W3CDTF">2021-04-07T08:05:30Z</dcterms:modified>
</cp:coreProperties>
</file>